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4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36" autoAdjust="0"/>
    <p:restoredTop sz="94620" autoAdjust="0"/>
  </p:normalViewPr>
  <p:slideViewPr>
    <p:cSldViewPr snapToGrid="0">
      <p:cViewPr>
        <p:scale>
          <a:sx n="170" d="100"/>
          <a:sy n="170" d="100"/>
        </p:scale>
        <p:origin x="1480" y="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CCCD-0DE2-41EA-99A5-A1DA61A6128D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EC2C9-52E5-40B7-B4E3-18E24763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80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4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9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7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4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0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Text Box 6">
            <a:extLst>
              <a:ext uri="{FF2B5EF4-FFF2-40B4-BE49-F238E27FC236}">
                <a16:creationId xmlns:a16="http://schemas.microsoft.com/office/drawing/2014/main" id="{8C2C3F67-CBBF-4502-A9EB-97EEA203AB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34184" y="302597"/>
            <a:ext cx="762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Fig S10</a:t>
            </a:r>
            <a:endParaRPr lang="en-US" sz="12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1A73AC06-6151-4CE9-B6FA-CF64B27C73DA}"/>
              </a:ext>
            </a:extLst>
          </p:cNvPr>
          <p:cNvSpPr txBox="1"/>
          <p:nvPr/>
        </p:nvSpPr>
        <p:spPr>
          <a:xfrm>
            <a:off x="571778" y="6266455"/>
            <a:ext cx="6106340" cy="17286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 S10:  Phosphokinase array blot of induced change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cell lines; WM1361(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NRAS*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A375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BRAF*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SK-MEL-119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NRAS*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ere exposed to doxycycline to induce BRAF*, NRAS* and BRAF* respectively.  Phosphokinase arrays were performed at Day 5. (a) In the heat map average phosphorylation of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protein kinases comprised of stress signaling pathway of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 cell lines enhanced after second oncogene induction, e.g. pMSK1/2 (&gt;2.43 fold), p38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 (&gt;2.7 fold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pERK1/2/3 (&gt;1.26 fold), JNK1/2/3 (&gt; 2.23 fold), GSK-3α/b (&gt;1.35 fold), and p-CREB (&gt;2.03 fold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olored tiles represent shared (  ) and cell specific regulation of phosphorylation of protein kinases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b) Densitometry was performed and normalized to reference spots (  ) on each blot.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ote: Human Phospho-Kinase Array Kit, catalog number ARY003B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RnDSystem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endParaRPr lang="en-US" sz="1100" b="1" baseline="30000" dirty="0">
              <a:solidFill>
                <a:srgbClr val="0046D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7" name="Picture 22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4370" y="7378411"/>
            <a:ext cx="100894" cy="82550"/>
          </a:xfrm>
          <a:prstGeom prst="rect">
            <a:avLst/>
          </a:prstGeom>
        </p:spPr>
      </p:pic>
      <p:sp>
        <p:nvSpPr>
          <p:cNvPr id="100" name="Rectangle 99">
            <a:extLst>
              <a:ext uri="{FF2B5EF4-FFF2-40B4-BE49-F238E27FC236}">
                <a16:creationId xmlns:a16="http://schemas.microsoft.com/office/drawing/2014/main" id="{3CDCFCE1-6A08-49DC-B2E5-89981BC7195F}"/>
              </a:ext>
            </a:extLst>
          </p:cNvPr>
          <p:cNvSpPr/>
          <p:nvPr/>
        </p:nvSpPr>
        <p:spPr>
          <a:xfrm>
            <a:off x="343178" y="617229"/>
            <a:ext cx="4613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51D535CC-C36C-4376-A422-21357494F19B}"/>
              </a:ext>
            </a:extLst>
          </p:cNvPr>
          <p:cNvGrpSpPr/>
          <p:nvPr/>
        </p:nvGrpSpPr>
        <p:grpSpPr>
          <a:xfrm>
            <a:off x="337598" y="4004436"/>
            <a:ext cx="5648335" cy="2113453"/>
            <a:chOff x="337598" y="3910746"/>
            <a:chExt cx="5648335" cy="211345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9167D1F9-C88E-4293-AAD8-0B83DEED15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607" t="9700"/>
            <a:stretch/>
          </p:blipFill>
          <p:spPr>
            <a:xfrm>
              <a:off x="4320669" y="4246222"/>
              <a:ext cx="1665264" cy="1777977"/>
            </a:xfrm>
            <a:prstGeom prst="rect">
              <a:avLst/>
            </a:prstGeom>
            <a:ln>
              <a:noFill/>
            </a:ln>
          </p:spPr>
        </p:pic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CB341CCF-9B67-40E3-9864-2CAA7A2E48FA}"/>
                </a:ext>
              </a:extLst>
            </p:cNvPr>
            <p:cNvSpPr/>
            <p:nvPr/>
          </p:nvSpPr>
          <p:spPr>
            <a:xfrm>
              <a:off x="4857899" y="4392740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9599E8ED-15EA-4AFB-9C5B-5BE6DD1FE9E8}"/>
                </a:ext>
              </a:extLst>
            </p:cNvPr>
            <p:cNvSpPr/>
            <p:nvPr/>
          </p:nvSpPr>
          <p:spPr>
            <a:xfrm>
              <a:off x="4384980" y="4393651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4392E3FC-DE04-4F69-A317-BAB5A28E2C20}"/>
                </a:ext>
              </a:extLst>
            </p:cNvPr>
            <p:cNvSpPr/>
            <p:nvPr/>
          </p:nvSpPr>
          <p:spPr>
            <a:xfrm>
              <a:off x="4867081" y="5793657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B96BD9A3-4260-4C4A-A479-2CC6A459E970}"/>
                </a:ext>
              </a:extLst>
            </p:cNvPr>
            <p:cNvSpPr/>
            <p:nvPr/>
          </p:nvSpPr>
          <p:spPr>
            <a:xfrm>
              <a:off x="5763603" y="4409296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AC82C016-6825-423A-BF87-8294B20C9A58}"/>
                </a:ext>
              </a:extLst>
            </p:cNvPr>
            <p:cNvSpPr/>
            <p:nvPr/>
          </p:nvSpPr>
          <p:spPr>
            <a:xfrm>
              <a:off x="5285794" y="4415097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44033F34-7571-46BE-A725-14DAEC1143D6}"/>
                </a:ext>
              </a:extLst>
            </p:cNvPr>
            <p:cNvSpPr/>
            <p:nvPr/>
          </p:nvSpPr>
          <p:spPr>
            <a:xfrm>
              <a:off x="5777676" y="5790320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5E2EEDE-F7DE-4A44-AE65-ABF65B575F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8190"/>
            <a:stretch/>
          </p:blipFill>
          <p:spPr>
            <a:xfrm>
              <a:off x="934293" y="4246198"/>
              <a:ext cx="1838757" cy="1778001"/>
            </a:xfrm>
            <a:prstGeom prst="rect">
              <a:avLst/>
            </a:prstGeom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836DC950-C297-4777-AFB2-ABDF919FCCE4}"/>
                </a:ext>
              </a:extLst>
            </p:cNvPr>
            <p:cNvSpPr/>
            <p:nvPr/>
          </p:nvSpPr>
          <p:spPr>
            <a:xfrm>
              <a:off x="1587990" y="4349318"/>
              <a:ext cx="102719" cy="135435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0E1BBA32-3AEC-47FD-B783-326BA3F5B9D8}"/>
                </a:ext>
              </a:extLst>
            </p:cNvPr>
            <p:cNvSpPr/>
            <p:nvPr/>
          </p:nvSpPr>
          <p:spPr>
            <a:xfrm>
              <a:off x="1155498" y="4346136"/>
              <a:ext cx="102719" cy="135435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F18AB529-E551-487E-830B-036C72BD1995}"/>
                </a:ext>
              </a:extLst>
            </p:cNvPr>
            <p:cNvSpPr/>
            <p:nvPr/>
          </p:nvSpPr>
          <p:spPr>
            <a:xfrm>
              <a:off x="1559827" y="5756416"/>
              <a:ext cx="102719" cy="135435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2ECD1189-13BC-437B-A551-8173FA1B5B4C}"/>
                </a:ext>
              </a:extLst>
            </p:cNvPr>
            <p:cNvSpPr/>
            <p:nvPr/>
          </p:nvSpPr>
          <p:spPr>
            <a:xfrm>
              <a:off x="2380747" y="4358895"/>
              <a:ext cx="102719" cy="135435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0AE49F88-9193-4A6F-83E3-3EC43DE4C226}"/>
                </a:ext>
              </a:extLst>
            </p:cNvPr>
            <p:cNvSpPr/>
            <p:nvPr/>
          </p:nvSpPr>
          <p:spPr>
            <a:xfrm>
              <a:off x="1953145" y="4360603"/>
              <a:ext cx="102719" cy="135435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773E10E3-07C5-43C0-AB37-5687E20C3F65}"/>
                </a:ext>
              </a:extLst>
            </p:cNvPr>
            <p:cNvSpPr/>
            <p:nvPr/>
          </p:nvSpPr>
          <p:spPr>
            <a:xfrm>
              <a:off x="2413280" y="5761103"/>
              <a:ext cx="102719" cy="135435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F43550BF-599F-4E81-920F-CC07BEB06B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401" t="9830" r="1665"/>
            <a:stretch/>
          </p:blipFill>
          <p:spPr>
            <a:xfrm>
              <a:off x="2658452" y="4246222"/>
              <a:ext cx="1628869" cy="1777977"/>
            </a:xfrm>
            <a:prstGeom prst="rect">
              <a:avLst/>
            </a:prstGeom>
          </p:spPr>
        </p:pic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B4233644-B3A7-4C42-BA34-A503B0182DA5}"/>
                </a:ext>
              </a:extLst>
            </p:cNvPr>
            <p:cNvSpPr/>
            <p:nvPr/>
          </p:nvSpPr>
          <p:spPr>
            <a:xfrm>
              <a:off x="3247012" y="5731957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B0A105C8-80C3-424B-B7B8-54CDC7A70452}"/>
                </a:ext>
              </a:extLst>
            </p:cNvPr>
            <p:cNvSpPr/>
            <p:nvPr/>
          </p:nvSpPr>
          <p:spPr>
            <a:xfrm>
              <a:off x="4121929" y="5742927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F6F4F40D-1BD9-470D-97F9-69AF811B1587}"/>
                </a:ext>
              </a:extLst>
            </p:cNvPr>
            <p:cNvSpPr/>
            <p:nvPr/>
          </p:nvSpPr>
          <p:spPr>
            <a:xfrm>
              <a:off x="4098811" y="4356021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23053462-92FB-4EE7-98F3-4062A41AE33C}"/>
                </a:ext>
              </a:extLst>
            </p:cNvPr>
            <p:cNvSpPr/>
            <p:nvPr/>
          </p:nvSpPr>
          <p:spPr>
            <a:xfrm>
              <a:off x="2803257" y="4383229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4398822" y="3972387"/>
              <a:ext cx="14654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K-MEL-119</a:t>
              </a:r>
              <a:r>
                <a:rPr lang="en-US" sz="7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RAS*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BRAF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1078620" y="3970986"/>
              <a:ext cx="14654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WM1361</a:t>
              </a:r>
              <a:r>
                <a:rPr lang="en-US" sz="7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RAS*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BRAF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2740279" y="3972387"/>
              <a:ext cx="14654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375</a:t>
              </a:r>
              <a:r>
                <a:rPr lang="en-US" sz="7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BRAF*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NRAS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A14559F5-6F67-409E-8B19-BF49F4D5B3B2}"/>
                </a:ext>
              </a:extLst>
            </p:cNvPr>
            <p:cNvSpPr/>
            <p:nvPr/>
          </p:nvSpPr>
          <p:spPr>
            <a:xfrm>
              <a:off x="3239295" y="4374634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4421191" y="4093470"/>
              <a:ext cx="6127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O DOX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5233020" y="4093470"/>
              <a:ext cx="6127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2763281" y="4094776"/>
              <a:ext cx="6127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NO DOX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3580000" y="4096089"/>
              <a:ext cx="6127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1093646" y="4093470"/>
              <a:ext cx="6127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NO DOX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1905475" y="4093470"/>
              <a:ext cx="6127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840404" y="4388660"/>
              <a:ext cx="25278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FAD8692B-051C-4047-BF38-7E9B20DE39B8}"/>
                </a:ext>
              </a:extLst>
            </p:cNvPr>
            <p:cNvSpPr txBox="1"/>
            <p:nvPr/>
          </p:nvSpPr>
          <p:spPr>
            <a:xfrm>
              <a:off x="839052" y="5388758"/>
              <a:ext cx="25278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184" name="Straight Connector 183"/>
            <p:cNvCxnSpPr/>
            <p:nvPr/>
          </p:nvCxnSpPr>
          <p:spPr>
            <a:xfrm>
              <a:off x="3469605" y="4158696"/>
              <a:ext cx="0" cy="1858048"/>
            </a:xfrm>
            <a:prstGeom prst="line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Straight Connector 184"/>
            <p:cNvCxnSpPr/>
            <p:nvPr/>
          </p:nvCxnSpPr>
          <p:spPr>
            <a:xfrm>
              <a:off x="5129483" y="4153665"/>
              <a:ext cx="0" cy="1858048"/>
            </a:xfrm>
            <a:prstGeom prst="line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Straight Connector 193"/>
            <p:cNvCxnSpPr/>
            <p:nvPr/>
          </p:nvCxnSpPr>
          <p:spPr>
            <a:xfrm>
              <a:off x="1807059" y="4156369"/>
              <a:ext cx="0" cy="1858048"/>
            </a:xfrm>
            <a:prstGeom prst="line">
              <a:avLst/>
            </a:prstGeom>
            <a:ln w="12700"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Rectangle 195">
              <a:extLst>
                <a:ext uri="{FF2B5EF4-FFF2-40B4-BE49-F238E27FC236}">
                  <a16:creationId xmlns:a16="http://schemas.microsoft.com/office/drawing/2014/main" id="{F6F4F40D-1BD9-470D-97F9-69AF811B1587}"/>
                </a:ext>
              </a:extLst>
            </p:cNvPr>
            <p:cNvSpPr/>
            <p:nvPr/>
          </p:nvSpPr>
          <p:spPr>
            <a:xfrm>
              <a:off x="3620412" y="4366611"/>
              <a:ext cx="102719" cy="133514"/>
            </a:xfrm>
            <a:prstGeom prst="rect">
              <a:avLst/>
            </a:prstGeom>
            <a:noFill/>
            <a:ln w="6350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id="{46925B36-23B4-4FB8-AF1B-1AFB16A71D21}"/>
                </a:ext>
              </a:extLst>
            </p:cNvPr>
            <p:cNvSpPr/>
            <p:nvPr/>
          </p:nvSpPr>
          <p:spPr>
            <a:xfrm>
              <a:off x="337598" y="3910746"/>
              <a:ext cx="46135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172" name="Rectangle 171">
            <a:extLst>
              <a:ext uri="{FF2B5EF4-FFF2-40B4-BE49-F238E27FC236}">
                <a16:creationId xmlns:a16="http://schemas.microsoft.com/office/drawing/2014/main" id="{E0920232-93A3-4D76-997D-D6C605B47B7A}"/>
              </a:ext>
            </a:extLst>
          </p:cNvPr>
          <p:cNvSpPr/>
          <p:nvPr/>
        </p:nvSpPr>
        <p:spPr>
          <a:xfrm>
            <a:off x="5444783" y="7542448"/>
            <a:ext cx="57150" cy="88900"/>
          </a:xfrm>
          <a:prstGeom prst="rect">
            <a:avLst/>
          </a:prstGeom>
          <a:noFill/>
          <a:ln w="95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A4FA533E-E3EA-4809-9722-1B6A15644D4C}"/>
              </a:ext>
            </a:extLst>
          </p:cNvPr>
          <p:cNvGrpSpPr/>
          <p:nvPr/>
        </p:nvGrpSpPr>
        <p:grpSpPr>
          <a:xfrm>
            <a:off x="393679" y="628198"/>
            <a:ext cx="5988044" cy="3080310"/>
            <a:chOff x="393679" y="763108"/>
            <a:chExt cx="5988044" cy="3080310"/>
          </a:xfrm>
        </p:grpSpPr>
        <p:sp>
          <p:nvSpPr>
            <p:cNvPr id="116" name="Rectangle 115"/>
            <p:cNvSpPr/>
            <p:nvPr/>
          </p:nvSpPr>
          <p:spPr>
            <a:xfrm>
              <a:off x="5311774" y="851057"/>
              <a:ext cx="641991" cy="263828"/>
            </a:xfrm>
            <a:prstGeom prst="rect">
              <a:avLst/>
            </a:prstGeom>
            <a:solidFill>
              <a:srgbClr val="00B0F0"/>
            </a:solid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BABC4CCB-E97C-4D59-A6F0-9881B9317D1B}"/>
                </a:ext>
              </a:extLst>
            </p:cNvPr>
            <p:cNvGrpSpPr/>
            <p:nvPr/>
          </p:nvGrpSpPr>
          <p:grpSpPr>
            <a:xfrm>
              <a:off x="5066345" y="3541055"/>
              <a:ext cx="1315378" cy="276221"/>
              <a:chOff x="2736215" y="3539148"/>
              <a:chExt cx="2491209" cy="572165"/>
            </a:xfrm>
          </p:grpSpPr>
          <p:sp>
            <p:nvSpPr>
              <p:cNvPr id="86" name="Rectangle 85">
                <a:extLst>
                  <a:ext uri="{FF2B5EF4-FFF2-40B4-BE49-F238E27FC236}">
                    <a16:creationId xmlns:a16="http://schemas.microsoft.com/office/drawing/2014/main" id="{7A0261E4-F00B-45A5-BB65-DA168202AB98}"/>
                  </a:ext>
                </a:extLst>
              </p:cNvPr>
              <p:cNvSpPr/>
              <p:nvPr/>
            </p:nvSpPr>
            <p:spPr>
              <a:xfrm>
                <a:off x="2901529" y="3539148"/>
                <a:ext cx="2060812" cy="191068"/>
              </a:xfrm>
              <a:prstGeom prst="rect">
                <a:avLst/>
              </a:prstGeom>
              <a:gradFill flip="none" rotWithShape="1">
                <a:gsLst>
                  <a:gs pos="0">
                    <a:srgbClr val="0000FC"/>
                  </a:gs>
                  <a:gs pos="50000">
                    <a:schemeClr val="bg1"/>
                  </a:gs>
                  <a:gs pos="100000">
                    <a:srgbClr val="FF0000"/>
                  </a:gs>
                </a:gsLst>
                <a:lin ang="0" scaled="1"/>
                <a:tileRect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E493AE22-9D24-4FA0-A636-292A78E8DDBB}"/>
                  </a:ext>
                </a:extLst>
              </p:cNvPr>
              <p:cNvSpPr txBox="1"/>
              <p:nvPr/>
            </p:nvSpPr>
            <p:spPr>
              <a:xfrm>
                <a:off x="4697259" y="3696918"/>
                <a:ext cx="530165" cy="4143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.42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A7B2387F-8032-49F4-AAFC-D1DD1BA12243}"/>
                  </a:ext>
                </a:extLst>
              </p:cNvPr>
              <p:cNvSpPr txBox="1"/>
              <p:nvPr/>
            </p:nvSpPr>
            <p:spPr>
              <a:xfrm>
                <a:off x="2736215" y="3696918"/>
                <a:ext cx="345720" cy="4143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F1ED4736-D49F-4FFF-8393-10AE26918977}"/>
                  </a:ext>
                </a:extLst>
              </p:cNvPr>
              <p:cNvSpPr txBox="1"/>
              <p:nvPr/>
            </p:nvSpPr>
            <p:spPr>
              <a:xfrm>
                <a:off x="3666855" y="3696918"/>
                <a:ext cx="530165" cy="4143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.18</a:t>
                </a: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393700" y="2749775"/>
              <a:ext cx="705833" cy="20005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WM1361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93681" y="2112140"/>
              <a:ext cx="702658" cy="2000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K-MEL-119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93700" y="2430270"/>
              <a:ext cx="705834" cy="20005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375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93700" y="1801394"/>
              <a:ext cx="705833" cy="20005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WM1361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93679" y="1183319"/>
              <a:ext cx="702659" cy="20005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K-MEL-119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93679" y="1496559"/>
              <a:ext cx="702659" cy="200055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375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086787" y="853888"/>
              <a:ext cx="1293960" cy="265282"/>
            </a:xfrm>
            <a:prstGeom prst="rect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168306" y="883692"/>
              <a:ext cx="12682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HARED (3 CELL LINES) </a:t>
              </a: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2385579" y="853888"/>
              <a:ext cx="637021" cy="26528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305284" y="836608"/>
              <a:ext cx="7072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WM1361,</a:t>
              </a:r>
            </a:p>
            <a:p>
              <a:pPr algn="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K-MEL-119</a:t>
              </a:r>
            </a:p>
          </p:txBody>
        </p:sp>
        <p:sp>
          <p:nvSpPr>
            <p:cNvPr id="158" name="Rectangle 157"/>
            <p:cNvSpPr/>
            <p:nvPr/>
          </p:nvSpPr>
          <p:spPr>
            <a:xfrm rot="5400000">
              <a:off x="5618042" y="1459985"/>
              <a:ext cx="939493" cy="268046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9" name="Rectangle 158"/>
            <p:cNvSpPr/>
            <p:nvPr/>
          </p:nvSpPr>
          <p:spPr>
            <a:xfrm rot="5400000">
              <a:off x="5625708" y="2404921"/>
              <a:ext cx="931334" cy="268046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0" name="TextBox 159"/>
            <p:cNvSpPr txBox="1"/>
            <p:nvPr/>
          </p:nvSpPr>
          <p:spPr>
            <a:xfrm rot="16200000">
              <a:off x="5819736" y="2434427"/>
              <a:ext cx="5389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NO DOX</a:t>
              </a:r>
            </a:p>
          </p:txBody>
        </p:sp>
        <p:sp>
          <p:nvSpPr>
            <p:cNvPr id="161" name="TextBox 160"/>
            <p:cNvSpPr txBox="1"/>
            <p:nvPr/>
          </p:nvSpPr>
          <p:spPr>
            <a:xfrm rot="16200000">
              <a:off x="5899886" y="1504932"/>
              <a:ext cx="3786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3563428" y="851054"/>
              <a:ext cx="1194310" cy="264881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292F0239-80E8-43B9-A783-6F32507B6AF4}"/>
                </a:ext>
              </a:extLst>
            </p:cNvPr>
            <p:cNvGrpSpPr/>
            <p:nvPr/>
          </p:nvGrpSpPr>
          <p:grpSpPr>
            <a:xfrm>
              <a:off x="2410408" y="893942"/>
              <a:ext cx="91758" cy="83271"/>
              <a:chOff x="2382700" y="647311"/>
              <a:chExt cx="104597" cy="83271"/>
            </a:xfrm>
          </p:grpSpPr>
          <p:sp>
            <p:nvSpPr>
              <p:cNvPr id="104" name="Oval 103">
                <a:extLst>
                  <a:ext uri="{FF2B5EF4-FFF2-40B4-BE49-F238E27FC236}">
                    <a16:creationId xmlns:a16="http://schemas.microsoft.com/office/drawing/2014/main" id="{3A752765-31AD-4444-8168-1187AFFD749A}"/>
                  </a:ext>
                </a:extLst>
              </p:cNvPr>
              <p:cNvSpPr/>
              <p:nvPr/>
            </p:nvSpPr>
            <p:spPr>
              <a:xfrm>
                <a:off x="2382700" y="647311"/>
                <a:ext cx="31550" cy="2850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5" name="Oval 104">
                <a:extLst>
                  <a:ext uri="{FF2B5EF4-FFF2-40B4-BE49-F238E27FC236}">
                    <a16:creationId xmlns:a16="http://schemas.microsoft.com/office/drawing/2014/main" id="{7A76335F-56F1-4C0E-88F5-3F09AD8B6FE1}"/>
                  </a:ext>
                </a:extLst>
              </p:cNvPr>
              <p:cNvSpPr/>
              <p:nvPr/>
            </p:nvSpPr>
            <p:spPr>
              <a:xfrm>
                <a:off x="2455747" y="675279"/>
                <a:ext cx="31550" cy="2850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08" name="Straight Connector 107">
                <a:extLst>
                  <a:ext uri="{FF2B5EF4-FFF2-40B4-BE49-F238E27FC236}">
                    <a16:creationId xmlns:a16="http://schemas.microsoft.com/office/drawing/2014/main" id="{C4177E56-6B4F-4EA2-9FBC-E5EE86EDA65A}"/>
                  </a:ext>
                </a:extLst>
              </p:cNvPr>
              <p:cNvCxnSpPr/>
              <p:nvPr/>
            </p:nvCxnSpPr>
            <p:spPr>
              <a:xfrm flipV="1">
                <a:off x="2407587" y="688271"/>
                <a:ext cx="70450" cy="2623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6A6D630C-510D-4335-9CF4-8D0D07ED1DD0}"/>
                  </a:ext>
                </a:extLst>
              </p:cNvPr>
              <p:cNvCxnSpPr/>
              <p:nvPr/>
            </p:nvCxnSpPr>
            <p:spPr>
              <a:xfrm>
                <a:off x="2389503" y="658262"/>
                <a:ext cx="91206" cy="290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Oval 109">
                <a:extLst>
                  <a:ext uri="{FF2B5EF4-FFF2-40B4-BE49-F238E27FC236}">
                    <a16:creationId xmlns:a16="http://schemas.microsoft.com/office/drawing/2014/main" id="{3D26C4DC-CD84-4DFF-A230-9D39E8636AEB}"/>
                  </a:ext>
                </a:extLst>
              </p:cNvPr>
              <p:cNvSpPr/>
              <p:nvPr/>
            </p:nvSpPr>
            <p:spPr>
              <a:xfrm>
                <a:off x="2385969" y="702080"/>
                <a:ext cx="31550" cy="2850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271626FC-CD73-4886-B0D3-632B7F5DF272}"/>
                </a:ext>
              </a:extLst>
            </p:cNvPr>
            <p:cNvGrpSpPr/>
            <p:nvPr/>
          </p:nvGrpSpPr>
          <p:grpSpPr>
            <a:xfrm>
              <a:off x="1147913" y="939687"/>
              <a:ext cx="91758" cy="83271"/>
              <a:chOff x="2382700" y="647311"/>
              <a:chExt cx="104597" cy="83271"/>
            </a:xfrm>
          </p:grpSpPr>
          <p:sp>
            <p:nvSpPr>
              <p:cNvPr id="130" name="Oval 129">
                <a:extLst>
                  <a:ext uri="{FF2B5EF4-FFF2-40B4-BE49-F238E27FC236}">
                    <a16:creationId xmlns:a16="http://schemas.microsoft.com/office/drawing/2014/main" id="{76597586-0FB2-4F97-930E-823ECF0E9F3A}"/>
                  </a:ext>
                </a:extLst>
              </p:cNvPr>
              <p:cNvSpPr/>
              <p:nvPr/>
            </p:nvSpPr>
            <p:spPr>
              <a:xfrm>
                <a:off x="2382700" y="647311"/>
                <a:ext cx="31550" cy="2850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1" name="Oval 130">
                <a:extLst>
                  <a:ext uri="{FF2B5EF4-FFF2-40B4-BE49-F238E27FC236}">
                    <a16:creationId xmlns:a16="http://schemas.microsoft.com/office/drawing/2014/main" id="{93FC2B3A-BAF2-4714-8BB6-93A5FE0FC5B5}"/>
                  </a:ext>
                </a:extLst>
              </p:cNvPr>
              <p:cNvSpPr/>
              <p:nvPr/>
            </p:nvSpPr>
            <p:spPr>
              <a:xfrm>
                <a:off x="2455747" y="675279"/>
                <a:ext cx="31550" cy="2850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76FBF7B0-3CC8-4430-B298-8978B92B08A3}"/>
                  </a:ext>
                </a:extLst>
              </p:cNvPr>
              <p:cNvCxnSpPr/>
              <p:nvPr/>
            </p:nvCxnSpPr>
            <p:spPr>
              <a:xfrm flipV="1">
                <a:off x="2407587" y="688271"/>
                <a:ext cx="70450" cy="2623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32">
                <a:extLst>
                  <a:ext uri="{FF2B5EF4-FFF2-40B4-BE49-F238E27FC236}">
                    <a16:creationId xmlns:a16="http://schemas.microsoft.com/office/drawing/2014/main" id="{A063B95F-EF88-4478-9E23-D540D42D95E0}"/>
                  </a:ext>
                </a:extLst>
              </p:cNvPr>
              <p:cNvCxnSpPr/>
              <p:nvPr/>
            </p:nvCxnSpPr>
            <p:spPr>
              <a:xfrm>
                <a:off x="2389503" y="658262"/>
                <a:ext cx="91206" cy="290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Oval 133">
                <a:extLst>
                  <a:ext uri="{FF2B5EF4-FFF2-40B4-BE49-F238E27FC236}">
                    <a16:creationId xmlns:a16="http://schemas.microsoft.com/office/drawing/2014/main" id="{787AA1E8-4CCC-4C1E-BEE5-373D4B00BFF0}"/>
                  </a:ext>
                </a:extLst>
              </p:cNvPr>
              <p:cNvSpPr/>
              <p:nvPr/>
            </p:nvSpPr>
            <p:spPr>
              <a:xfrm>
                <a:off x="2385969" y="702080"/>
                <a:ext cx="31550" cy="2850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07" name="TextBox 106"/>
            <p:cNvSpPr txBox="1"/>
            <p:nvPr/>
          </p:nvSpPr>
          <p:spPr>
            <a:xfrm>
              <a:off x="3821027" y="840498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K-MEL-119 </a:t>
              </a:r>
            </a:p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PECIFIC</a:t>
              </a:r>
            </a:p>
          </p:txBody>
        </p:sp>
        <p:sp>
          <p:nvSpPr>
            <p:cNvPr id="98" name="Rectangle 97"/>
            <p:cNvSpPr/>
            <p:nvPr/>
          </p:nvSpPr>
          <p:spPr>
            <a:xfrm>
              <a:off x="3034797" y="851933"/>
              <a:ext cx="534237" cy="265282"/>
            </a:xfrm>
            <a:prstGeom prst="rect">
              <a:avLst/>
            </a:prstGeom>
            <a:solidFill>
              <a:srgbClr val="8190E6"/>
            </a:solidFill>
            <a:ln>
              <a:solidFill>
                <a:srgbClr val="8190E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948966" y="851693"/>
              <a:ext cx="7072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A375,</a:t>
              </a:r>
            </a:p>
            <a:p>
              <a:pPr algn="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K-MEL-119</a:t>
              </a:r>
            </a:p>
          </p:txBody>
        </p:sp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ACAD9A63-FDEA-49AC-9FED-DECAC5577B6D}"/>
                </a:ext>
              </a:extLst>
            </p:cNvPr>
            <p:cNvGrpSpPr/>
            <p:nvPr/>
          </p:nvGrpSpPr>
          <p:grpSpPr>
            <a:xfrm>
              <a:off x="3191529" y="905489"/>
              <a:ext cx="91758" cy="83271"/>
              <a:chOff x="2382700" y="647311"/>
              <a:chExt cx="104597" cy="83271"/>
            </a:xfrm>
          </p:grpSpPr>
          <p:sp>
            <p:nvSpPr>
              <p:cNvPr id="148" name="Oval 147">
                <a:extLst>
                  <a:ext uri="{FF2B5EF4-FFF2-40B4-BE49-F238E27FC236}">
                    <a16:creationId xmlns:a16="http://schemas.microsoft.com/office/drawing/2014/main" id="{F9AA8483-42FA-49B9-9C27-3429CA785EE0}"/>
                  </a:ext>
                </a:extLst>
              </p:cNvPr>
              <p:cNvSpPr/>
              <p:nvPr/>
            </p:nvSpPr>
            <p:spPr>
              <a:xfrm>
                <a:off x="2382700" y="647311"/>
                <a:ext cx="31550" cy="2850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6" name="Oval 155">
                <a:extLst>
                  <a:ext uri="{FF2B5EF4-FFF2-40B4-BE49-F238E27FC236}">
                    <a16:creationId xmlns:a16="http://schemas.microsoft.com/office/drawing/2014/main" id="{2CBEC9A2-C86F-438C-ACE8-5BF6D50DF7F0}"/>
                  </a:ext>
                </a:extLst>
              </p:cNvPr>
              <p:cNvSpPr/>
              <p:nvPr/>
            </p:nvSpPr>
            <p:spPr>
              <a:xfrm>
                <a:off x="2455747" y="675279"/>
                <a:ext cx="31550" cy="2850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57" name="Straight Connector 156">
                <a:extLst>
                  <a:ext uri="{FF2B5EF4-FFF2-40B4-BE49-F238E27FC236}">
                    <a16:creationId xmlns:a16="http://schemas.microsoft.com/office/drawing/2014/main" id="{5FC27F6C-602A-4B17-972E-B33B68FB5634}"/>
                  </a:ext>
                </a:extLst>
              </p:cNvPr>
              <p:cNvCxnSpPr/>
              <p:nvPr/>
            </p:nvCxnSpPr>
            <p:spPr>
              <a:xfrm flipV="1">
                <a:off x="2407587" y="688271"/>
                <a:ext cx="70450" cy="2623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Straight Connector 169">
                <a:extLst>
                  <a:ext uri="{FF2B5EF4-FFF2-40B4-BE49-F238E27FC236}">
                    <a16:creationId xmlns:a16="http://schemas.microsoft.com/office/drawing/2014/main" id="{396BCE61-DA8A-4224-94D1-78DC59B54059}"/>
                  </a:ext>
                </a:extLst>
              </p:cNvPr>
              <p:cNvCxnSpPr/>
              <p:nvPr/>
            </p:nvCxnSpPr>
            <p:spPr>
              <a:xfrm>
                <a:off x="2389503" y="658262"/>
                <a:ext cx="91206" cy="290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1" name="Oval 170">
                <a:extLst>
                  <a:ext uri="{FF2B5EF4-FFF2-40B4-BE49-F238E27FC236}">
                    <a16:creationId xmlns:a16="http://schemas.microsoft.com/office/drawing/2014/main" id="{AC5D312C-F3B4-4CC5-953B-876702DCB2D4}"/>
                  </a:ext>
                </a:extLst>
              </p:cNvPr>
              <p:cNvSpPr/>
              <p:nvPr/>
            </p:nvSpPr>
            <p:spPr>
              <a:xfrm>
                <a:off x="2385969" y="702080"/>
                <a:ext cx="31550" cy="2850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7" name="TextBox 116"/>
            <p:cNvSpPr txBox="1"/>
            <p:nvPr/>
          </p:nvSpPr>
          <p:spPr>
            <a:xfrm>
              <a:off x="5314949" y="884289"/>
              <a:ext cx="59577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NACTIVE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AABBE377-5833-4690-AA90-6A8D8D796D6F}"/>
                </a:ext>
              </a:extLst>
            </p:cNvPr>
            <p:cNvSpPr/>
            <p:nvPr/>
          </p:nvSpPr>
          <p:spPr>
            <a:xfrm>
              <a:off x="4868863" y="851057"/>
              <a:ext cx="430146" cy="261784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B414E83B-6ACD-45DC-9057-F88B6A2BE3A4}"/>
                </a:ext>
              </a:extLst>
            </p:cNvPr>
            <p:cNvSpPr txBox="1"/>
            <p:nvPr/>
          </p:nvSpPr>
          <p:spPr>
            <a:xfrm>
              <a:off x="4799522" y="825487"/>
              <a:ext cx="5661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</a:p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HANGE</a:t>
              </a:r>
            </a:p>
          </p:txBody>
        </p:sp>
        <p:sp>
          <p:nvSpPr>
            <p:cNvPr id="114" name="Rectangle 113"/>
            <p:cNvSpPr/>
            <p:nvPr/>
          </p:nvSpPr>
          <p:spPr>
            <a:xfrm>
              <a:off x="4769644" y="851054"/>
              <a:ext cx="97437" cy="268089"/>
            </a:xfrm>
            <a:prstGeom prst="rect">
              <a:avLst/>
            </a:prstGeom>
            <a:solidFill>
              <a:srgbClr val="92B3E7"/>
            </a:solidFill>
            <a:ln>
              <a:solidFill>
                <a:srgbClr val="92B3E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/>
            <p:cNvSpPr/>
            <p:nvPr/>
          </p:nvSpPr>
          <p:spPr>
            <a:xfrm rot="16200000">
              <a:off x="4593465" y="896528"/>
              <a:ext cx="436118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WM1361</a:t>
              </a:r>
              <a:endParaRPr lang="en-US" sz="500" b="1" dirty="0"/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6096063D-8573-4B4A-B454-F235DE6A09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1102" t="414" b="1011"/>
            <a:stretch/>
          </p:blipFill>
          <p:spPr>
            <a:xfrm rot="16200000">
              <a:off x="2155754" y="42804"/>
              <a:ext cx="2725324" cy="487590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39471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</TotalTime>
  <Words>214</Words>
  <Application>Microsoft Macintosh PowerPoint</Application>
  <PresentationFormat>Letter Paper (8.5x11 in)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Raj</dc:creator>
  <cp:lastModifiedBy>Kumar, Raj</cp:lastModifiedBy>
  <cp:revision>42</cp:revision>
  <dcterms:created xsi:type="dcterms:W3CDTF">2018-08-13T22:54:38Z</dcterms:created>
  <dcterms:modified xsi:type="dcterms:W3CDTF">2018-12-28T18:18:45Z</dcterms:modified>
</cp:coreProperties>
</file>